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7772400" cy="10058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41" d="100"/>
          <a:sy n="41" d="100"/>
        </p:scale>
        <p:origin x="2208" y="2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Jennifer\Dropbox\Moore%20Lab\EGR1%20paper\Densitometries\Densitometrie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Jennifer\Dropbox\Moore%20Lab\EGR1%20paper\Densitometries\Densitometrie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>
                <a:solidFill>
                  <a:schemeClr val="tx1"/>
                </a:solidFill>
              </a:rPr>
              <a:t>p-</a:t>
            </a:r>
            <a:r>
              <a:rPr lang="en-US" dirty="0" err="1" smtClean="0">
                <a:solidFill>
                  <a:schemeClr val="tx1"/>
                </a:solidFill>
              </a:rPr>
              <a:t>ERK</a:t>
            </a:r>
            <a:r>
              <a:rPr lang="en-US" dirty="0" smtClean="0">
                <a:solidFill>
                  <a:schemeClr val="tx1"/>
                </a:solidFill>
              </a:rPr>
              <a:t>/</a:t>
            </a:r>
            <a:r>
              <a:rPr lang="en-US" dirty="0" err="1" smtClean="0">
                <a:solidFill>
                  <a:schemeClr val="tx1"/>
                </a:solidFill>
              </a:rPr>
              <a:t>ERK</a:t>
            </a:r>
            <a:r>
              <a:rPr lang="en-US" dirty="0" smtClean="0">
                <a:solidFill>
                  <a:schemeClr val="tx1"/>
                </a:solidFill>
              </a:rPr>
              <a:t> Densitometry</a:t>
            </a:r>
            <a:endParaRPr lang="en-US" dirty="0">
              <a:solidFill>
                <a:schemeClr val="tx1"/>
              </a:solidFill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J$1</c:f>
              <c:strCache>
                <c:ptCount val="1"/>
                <c:pt idx="0">
                  <c:v>p-ERK/ERK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Sheet1!$I$2:$I$16</c:f>
              <c:strCache>
                <c:ptCount val="15"/>
                <c:pt idx="0">
                  <c:v>Untrx-NV</c:v>
                </c:pt>
                <c:pt idx="1">
                  <c:v>Untrx-C1</c:v>
                </c:pt>
                <c:pt idx="2">
                  <c:v>Untrx-C7</c:v>
                </c:pt>
                <c:pt idx="3">
                  <c:v>1h-NV</c:v>
                </c:pt>
                <c:pt idx="4">
                  <c:v>1h-C1</c:v>
                </c:pt>
                <c:pt idx="5">
                  <c:v>1h-C7</c:v>
                </c:pt>
                <c:pt idx="6">
                  <c:v>3h-NV</c:v>
                </c:pt>
                <c:pt idx="7">
                  <c:v>3h-C1</c:v>
                </c:pt>
                <c:pt idx="8">
                  <c:v>3h-C7</c:v>
                </c:pt>
                <c:pt idx="9">
                  <c:v>6h-NV</c:v>
                </c:pt>
                <c:pt idx="10">
                  <c:v>6h-C1</c:v>
                </c:pt>
                <c:pt idx="11">
                  <c:v>6h-C7</c:v>
                </c:pt>
                <c:pt idx="12">
                  <c:v>9h-NV</c:v>
                </c:pt>
                <c:pt idx="13">
                  <c:v>9h-C1</c:v>
                </c:pt>
                <c:pt idx="14">
                  <c:v>9h-C7</c:v>
                </c:pt>
              </c:strCache>
            </c:strRef>
          </c:cat>
          <c:val>
            <c:numRef>
              <c:f>Sheet1!$J$2:$J$16</c:f>
              <c:numCache>
                <c:formatCode>General</c:formatCode>
                <c:ptCount val="15"/>
                <c:pt idx="0">
                  <c:v>1</c:v>
                </c:pt>
                <c:pt idx="1">
                  <c:v>1.0219563334670656</c:v>
                </c:pt>
                <c:pt idx="2">
                  <c:v>2.6989729638999633</c:v>
                </c:pt>
                <c:pt idx="3">
                  <c:v>8.7629385306568182</c:v>
                </c:pt>
                <c:pt idx="4">
                  <c:v>1.7755568166784605</c:v>
                </c:pt>
                <c:pt idx="5">
                  <c:v>3.6334420035028683</c:v>
                </c:pt>
                <c:pt idx="6">
                  <c:v>10.147512689209881</c:v>
                </c:pt>
                <c:pt idx="7">
                  <c:v>3.0894186232615954</c:v>
                </c:pt>
                <c:pt idx="8">
                  <c:v>13.774067424463665</c:v>
                </c:pt>
                <c:pt idx="9">
                  <c:v>163.43220434772113</c:v>
                </c:pt>
                <c:pt idx="10">
                  <c:v>49.738037281044157</c:v>
                </c:pt>
                <c:pt idx="11">
                  <c:v>73.542161353892041</c:v>
                </c:pt>
                <c:pt idx="12">
                  <c:v>128.23107250508841</c:v>
                </c:pt>
                <c:pt idx="13">
                  <c:v>71.514586554145069</c:v>
                </c:pt>
                <c:pt idx="14">
                  <c:v>146.1825988063496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4520184"/>
        <c:axId val="424518224"/>
      </c:barChart>
      <c:catAx>
        <c:axId val="4245201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24518224"/>
        <c:crosses val="autoZero"/>
        <c:auto val="1"/>
        <c:lblAlgn val="ctr"/>
        <c:lblOffset val="100"/>
        <c:noMultiLvlLbl val="0"/>
      </c:catAx>
      <c:valAx>
        <c:axId val="42451822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>
                    <a:solidFill>
                      <a:schemeClr val="tx1"/>
                    </a:solidFill>
                  </a:rPr>
                  <a:t>Relative Band Intensity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245201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>
                <a:solidFill>
                  <a:schemeClr val="tx1"/>
                </a:solidFill>
              </a:rPr>
              <a:t>p-</a:t>
            </a:r>
            <a:r>
              <a:rPr lang="en-US" dirty="0" err="1" smtClean="0">
                <a:solidFill>
                  <a:schemeClr val="tx1"/>
                </a:solidFill>
              </a:rPr>
              <a:t>p38</a:t>
            </a:r>
            <a:r>
              <a:rPr lang="en-US" dirty="0" smtClean="0">
                <a:solidFill>
                  <a:schemeClr val="tx1"/>
                </a:solidFill>
              </a:rPr>
              <a:t>/</a:t>
            </a:r>
            <a:r>
              <a:rPr lang="en-US" dirty="0" err="1" smtClean="0">
                <a:solidFill>
                  <a:schemeClr val="tx1"/>
                </a:solidFill>
              </a:rPr>
              <a:t>p38</a:t>
            </a:r>
            <a:r>
              <a:rPr lang="en-US" dirty="0" smtClean="0">
                <a:solidFill>
                  <a:schemeClr val="tx1"/>
                </a:solidFill>
              </a:rPr>
              <a:t> Densitometry</a:t>
            </a:r>
            <a:endParaRPr lang="en-US" dirty="0">
              <a:solidFill>
                <a:schemeClr val="tx1"/>
              </a:solidFill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L$1</c:f>
              <c:strCache>
                <c:ptCount val="1"/>
                <c:pt idx="0">
                  <c:v>p-p38/p38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Sheet1!$K$2:$K$16</c:f>
              <c:strCache>
                <c:ptCount val="15"/>
                <c:pt idx="0">
                  <c:v>Untrx-NV</c:v>
                </c:pt>
                <c:pt idx="1">
                  <c:v>Untrx-C1</c:v>
                </c:pt>
                <c:pt idx="2">
                  <c:v>Untrx-C7</c:v>
                </c:pt>
                <c:pt idx="3">
                  <c:v>1h-NV</c:v>
                </c:pt>
                <c:pt idx="4">
                  <c:v>1h-C1</c:v>
                </c:pt>
                <c:pt idx="5">
                  <c:v>1h-C7</c:v>
                </c:pt>
                <c:pt idx="6">
                  <c:v>3h-NV</c:v>
                </c:pt>
                <c:pt idx="7">
                  <c:v>3h-C1</c:v>
                </c:pt>
                <c:pt idx="8">
                  <c:v>3h-C7</c:v>
                </c:pt>
                <c:pt idx="9">
                  <c:v>6h-NV</c:v>
                </c:pt>
                <c:pt idx="10">
                  <c:v>6h-C1</c:v>
                </c:pt>
                <c:pt idx="11">
                  <c:v>6h-C7</c:v>
                </c:pt>
                <c:pt idx="12">
                  <c:v>9h-NV</c:v>
                </c:pt>
                <c:pt idx="13">
                  <c:v>9h-C1</c:v>
                </c:pt>
                <c:pt idx="14">
                  <c:v>9h-C7</c:v>
                </c:pt>
              </c:strCache>
            </c:strRef>
          </c:cat>
          <c:val>
            <c:numRef>
              <c:f>Sheet1!$L$2:$L$16</c:f>
              <c:numCache>
                <c:formatCode>General</c:formatCode>
                <c:ptCount val="15"/>
                <c:pt idx="0">
                  <c:v>10.661238516502213</c:v>
                </c:pt>
                <c:pt idx="1">
                  <c:v>2.5110094242851653</c:v>
                </c:pt>
                <c:pt idx="2">
                  <c:v>1.7265358615658264</c:v>
                </c:pt>
                <c:pt idx="3">
                  <c:v>1</c:v>
                </c:pt>
                <c:pt idx="4">
                  <c:v>1.2826556827838937</c:v>
                </c:pt>
                <c:pt idx="5">
                  <c:v>1.2737022077833389</c:v>
                </c:pt>
                <c:pt idx="6">
                  <c:v>1298.8709178344022</c:v>
                </c:pt>
                <c:pt idx="7">
                  <c:v>1.8723284999444278</c:v>
                </c:pt>
                <c:pt idx="8">
                  <c:v>9235.6482148153682</c:v>
                </c:pt>
                <c:pt idx="9">
                  <c:v>25741.077309764198</c:v>
                </c:pt>
                <c:pt idx="10">
                  <c:v>6944.0513300959765</c:v>
                </c:pt>
                <c:pt idx="11">
                  <c:v>6605.6231236569101</c:v>
                </c:pt>
                <c:pt idx="12">
                  <c:v>5862.5918906270726</c:v>
                </c:pt>
                <c:pt idx="13">
                  <c:v>7098.0983648851188</c:v>
                </c:pt>
                <c:pt idx="14">
                  <c:v>16047.87470420012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4520576"/>
        <c:axId val="424519008"/>
      </c:barChart>
      <c:catAx>
        <c:axId val="4245205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24519008"/>
        <c:crosses val="autoZero"/>
        <c:auto val="1"/>
        <c:lblAlgn val="ctr"/>
        <c:lblOffset val="100"/>
        <c:noMultiLvlLbl val="0"/>
      </c:catAx>
      <c:valAx>
        <c:axId val="4245190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>
                    <a:solidFill>
                      <a:schemeClr val="tx1"/>
                    </a:solidFill>
                  </a:rPr>
                  <a:t>Relative Band Intensity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245205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5ADF4-FB5D-4C18-982E-418B7C1F273D}" type="datetimeFigureOut">
              <a:rPr lang="en-US" smtClean="0"/>
              <a:t>3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D1ED8-4F41-4627-A198-3CAA32B706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16572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5ADF4-FB5D-4C18-982E-418B7C1F273D}" type="datetimeFigureOut">
              <a:rPr lang="en-US" smtClean="0"/>
              <a:t>3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D1ED8-4F41-4627-A198-3CAA32B706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33790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5ADF4-FB5D-4C18-982E-418B7C1F273D}" type="datetimeFigureOut">
              <a:rPr lang="en-US" smtClean="0"/>
              <a:t>3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D1ED8-4F41-4627-A198-3CAA32B706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66691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5ADF4-FB5D-4C18-982E-418B7C1F273D}" type="datetimeFigureOut">
              <a:rPr lang="en-US" smtClean="0"/>
              <a:t>3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D1ED8-4F41-4627-A198-3CAA32B706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97787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5ADF4-FB5D-4C18-982E-418B7C1F273D}" type="datetimeFigureOut">
              <a:rPr lang="en-US" smtClean="0"/>
              <a:t>3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D1ED8-4F41-4627-A198-3CAA32B706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34600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5ADF4-FB5D-4C18-982E-418B7C1F273D}" type="datetimeFigureOut">
              <a:rPr lang="en-US" smtClean="0"/>
              <a:t>3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D1ED8-4F41-4627-A198-3CAA32B706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16725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5ADF4-FB5D-4C18-982E-418B7C1F273D}" type="datetimeFigureOut">
              <a:rPr lang="en-US" smtClean="0"/>
              <a:t>3/1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D1ED8-4F41-4627-A198-3CAA32B706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9276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5ADF4-FB5D-4C18-982E-418B7C1F273D}" type="datetimeFigureOut">
              <a:rPr lang="en-US" smtClean="0"/>
              <a:t>3/1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D1ED8-4F41-4627-A198-3CAA32B706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04214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5ADF4-FB5D-4C18-982E-418B7C1F273D}" type="datetimeFigureOut">
              <a:rPr lang="en-US" smtClean="0"/>
              <a:t>3/1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D1ED8-4F41-4627-A198-3CAA32B706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0084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5ADF4-FB5D-4C18-982E-418B7C1F273D}" type="datetimeFigureOut">
              <a:rPr lang="en-US" smtClean="0"/>
              <a:t>3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D1ED8-4F41-4627-A198-3CAA32B706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75475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5ADF4-FB5D-4C18-982E-418B7C1F273D}" type="datetimeFigureOut">
              <a:rPr lang="en-US" smtClean="0"/>
              <a:t>3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D1ED8-4F41-4627-A198-3CAA32B706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04291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A5ADF4-FB5D-4C18-982E-418B7C1F273D}" type="datetimeFigureOut">
              <a:rPr lang="en-US" smtClean="0"/>
              <a:t>3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1D1ED8-4F41-4627-A198-3CAA32B706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95540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72667976"/>
              </p:ext>
            </p:extLst>
          </p:nvPr>
        </p:nvGraphicFramePr>
        <p:xfrm>
          <a:off x="648832" y="6914355"/>
          <a:ext cx="6592824" cy="29535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67477046"/>
              </p:ext>
            </p:extLst>
          </p:nvPr>
        </p:nvGraphicFramePr>
        <p:xfrm>
          <a:off x="650156" y="3869177"/>
          <a:ext cx="6594686" cy="295326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648832" y="202335"/>
            <a:ext cx="292240" cy="3416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0" b="1" dirty="0" smtClean="0"/>
              <a:t>A</a:t>
            </a:r>
            <a:endParaRPr lang="en-US" sz="162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648832" y="3907181"/>
            <a:ext cx="292240" cy="3416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0" b="1" dirty="0" smtClean="0"/>
              <a:t>B</a:t>
            </a:r>
            <a:endParaRPr lang="en-US" sz="162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671721" y="6962536"/>
            <a:ext cx="292240" cy="3416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0" b="1" dirty="0"/>
              <a:t>C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1721" y="240383"/>
            <a:ext cx="6669910" cy="35368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783522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3</Words>
  <Application>Microsoft Office PowerPoint</Application>
  <PresentationFormat>Custom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uthor</dc:creator>
  <cp:lastModifiedBy>Author</cp:lastModifiedBy>
  <cp:revision>1</cp:revision>
  <dcterms:created xsi:type="dcterms:W3CDTF">2016-03-01T16:18:59Z</dcterms:created>
  <dcterms:modified xsi:type="dcterms:W3CDTF">2016-03-01T16:19:17Z</dcterms:modified>
</cp:coreProperties>
</file>